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9" r:id="rId2"/>
    <p:sldId id="260" r:id="rId3"/>
    <p:sldId id="261" r:id="rId4"/>
    <p:sldId id="258" r:id="rId5"/>
    <p:sldId id="262" r:id="rId6"/>
    <p:sldId id="263" r:id="rId7"/>
    <p:sldId id="264" r:id="rId8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696" y="82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DC53D3-52FD-4BCE-9A41-5699CF2D5E61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EC363C-6AF5-4273-9C11-89EE7AE938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87260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EC363C-6AF5-4273-9C11-89EE7AE938AB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6424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7348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3487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5791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8031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641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6335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3495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685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534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2338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3997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4D6BF-A42D-4F9E-AB9D-7B9D418AB252}" type="datetimeFigureOut">
              <a:rPr lang="ko-KR" altLang="en-US" smtClean="0"/>
              <a:t>2021-04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6CB6AA-B419-4DCB-B355-A7B10EACCB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105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jpe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png"/><Relationship Id="rId10" Type="http://schemas.openxmlformats.org/officeDocument/2006/relationships/image" Target="../media/image8.jpeg"/><Relationship Id="rId4" Type="http://schemas.openxmlformats.org/officeDocument/2006/relationships/image" Target="../media/image2.pn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13" Type="http://schemas.openxmlformats.org/officeDocument/2006/relationships/image" Target="../media/image24.png"/><Relationship Id="rId18" Type="http://schemas.openxmlformats.org/officeDocument/2006/relationships/image" Target="../media/image29.jpeg"/><Relationship Id="rId3" Type="http://schemas.openxmlformats.org/officeDocument/2006/relationships/image" Target="../media/image14.jpeg"/><Relationship Id="rId21" Type="http://schemas.openxmlformats.org/officeDocument/2006/relationships/image" Target="../media/image32.jpeg"/><Relationship Id="rId7" Type="http://schemas.openxmlformats.org/officeDocument/2006/relationships/image" Target="../media/image18.jpeg"/><Relationship Id="rId12" Type="http://schemas.openxmlformats.org/officeDocument/2006/relationships/image" Target="../media/image23.jpeg"/><Relationship Id="rId17" Type="http://schemas.openxmlformats.org/officeDocument/2006/relationships/image" Target="../media/image28.jpeg"/><Relationship Id="rId2" Type="http://schemas.openxmlformats.org/officeDocument/2006/relationships/image" Target="../media/image13.png"/><Relationship Id="rId16" Type="http://schemas.openxmlformats.org/officeDocument/2006/relationships/image" Target="../media/image27.jpeg"/><Relationship Id="rId20" Type="http://schemas.openxmlformats.org/officeDocument/2006/relationships/image" Target="../media/image3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eg"/><Relationship Id="rId11" Type="http://schemas.openxmlformats.org/officeDocument/2006/relationships/image" Target="../media/image22.jpeg"/><Relationship Id="rId5" Type="http://schemas.openxmlformats.org/officeDocument/2006/relationships/image" Target="../media/image16.jpeg"/><Relationship Id="rId15" Type="http://schemas.openxmlformats.org/officeDocument/2006/relationships/image" Target="../media/image26.png"/><Relationship Id="rId10" Type="http://schemas.openxmlformats.org/officeDocument/2006/relationships/image" Target="../media/image21.jpeg"/><Relationship Id="rId19" Type="http://schemas.openxmlformats.org/officeDocument/2006/relationships/image" Target="../media/image30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Relationship Id="rId14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4242" y="848544"/>
            <a:ext cx="1484313" cy="498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700" y="855663"/>
            <a:ext cx="2095500" cy="463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4242" y="1503735"/>
            <a:ext cx="1512887" cy="479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3225" y="1497385"/>
            <a:ext cx="2085975" cy="492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4242" y="2079799"/>
            <a:ext cx="1522413" cy="685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9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7663" y="2079799"/>
            <a:ext cx="2141537" cy="676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2960" y="3333502"/>
            <a:ext cx="2141537" cy="52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1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9" b="17774"/>
          <a:stretch/>
        </p:blipFill>
        <p:spPr bwMode="auto">
          <a:xfrm>
            <a:off x="3865647" y="3333502"/>
            <a:ext cx="2112099" cy="532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1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2960" y="3956308"/>
            <a:ext cx="2105025" cy="488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13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7"/>
          <a:stretch/>
        </p:blipFill>
        <p:spPr bwMode="auto">
          <a:xfrm>
            <a:off x="3884697" y="3909794"/>
            <a:ext cx="2093049" cy="5730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14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2960" y="4536182"/>
            <a:ext cx="2160587" cy="70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15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5259" y="4564757"/>
            <a:ext cx="2122487" cy="676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332657" y="5601072"/>
            <a:ext cx="62646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" panose="02020603050405020304" pitchFamily="18" charset="0"/>
                <a:cs typeface="times" panose="02020603050405020304" pitchFamily="18" charset="0"/>
              </a:rPr>
              <a:t>Original blot images related to Figure 2F) and 2G) : 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 images for Figure 2. red arrows indicate predicted protein size. For Figure 2F 1:Untreated control, 2: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Vehicle, 3: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x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0.625 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µM of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iclosamide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. For Figure 2G, 1: Untreated control, 2: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Dexa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+ Vehicle, 3: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Dexa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+ 150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M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of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iclosamide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, 4: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Dexa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+ 300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M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of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iclosamide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00680" y="272480"/>
            <a:ext cx="3388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Figure 2F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00680" y="2886254"/>
            <a:ext cx="3235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</a:t>
            </a:r>
            <a:r>
              <a:rPr lang="en-GB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</a:t>
            </a:r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G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799104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002640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198672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356500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560036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2756068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510628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714164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910196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4084692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288228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484260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4655136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858672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5054704" y="8028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1806724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010260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206292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2364120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2567656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763688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518248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721784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3917816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092312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295848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491880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662756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866292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062324" y="150062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821964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025500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221532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2379360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2582896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778928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3533488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737024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933056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4107552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4311088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507120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677996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4881532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5077564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859808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053312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246816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440320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810388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003892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3197396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3390900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4250548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444052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4637556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4831060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5187416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5380920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574424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767928" y="331967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833776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2027280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2220784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2414288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2784356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2977860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3171364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364868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4270236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4463740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4657244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4850748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5207104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5400608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5594112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5787616" y="394146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1867684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061188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254692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448196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2818264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3011768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205272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3398776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4243948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4437452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4630956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4824460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5180816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5374320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5567824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5761328" y="482823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166" name="직선 화살표 연결선 165"/>
          <p:cNvCxnSpPr/>
          <p:nvPr/>
        </p:nvCxnSpPr>
        <p:spPr>
          <a:xfrm>
            <a:off x="1254471" y="1126487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직선 화살표 연결선 166"/>
          <p:cNvCxnSpPr/>
          <p:nvPr/>
        </p:nvCxnSpPr>
        <p:spPr>
          <a:xfrm>
            <a:off x="1254471" y="1775122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직선 화살표 연결선 167"/>
          <p:cNvCxnSpPr/>
          <p:nvPr/>
        </p:nvCxnSpPr>
        <p:spPr>
          <a:xfrm>
            <a:off x="1254471" y="2623344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직선 화살표 연결선 168"/>
          <p:cNvCxnSpPr/>
          <p:nvPr/>
        </p:nvCxnSpPr>
        <p:spPr>
          <a:xfrm>
            <a:off x="2980836" y="1096318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직선 화살표 연결선 169"/>
          <p:cNvCxnSpPr/>
          <p:nvPr/>
        </p:nvCxnSpPr>
        <p:spPr>
          <a:xfrm>
            <a:off x="2980836" y="1795753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직선 화살표 연결선 170"/>
          <p:cNvCxnSpPr/>
          <p:nvPr/>
        </p:nvCxnSpPr>
        <p:spPr>
          <a:xfrm>
            <a:off x="2980836" y="2682075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직선 화살표 연결선 171"/>
          <p:cNvCxnSpPr/>
          <p:nvPr/>
        </p:nvCxnSpPr>
        <p:spPr>
          <a:xfrm>
            <a:off x="1312716" y="3633996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직선 화살표 연결선 172"/>
          <p:cNvCxnSpPr/>
          <p:nvPr/>
        </p:nvCxnSpPr>
        <p:spPr>
          <a:xfrm>
            <a:off x="1312716" y="4255780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직선 화살표 연결선 173"/>
          <p:cNvCxnSpPr/>
          <p:nvPr/>
        </p:nvCxnSpPr>
        <p:spPr>
          <a:xfrm>
            <a:off x="3743320" y="3589040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직선 화살표 연결선 174"/>
          <p:cNvCxnSpPr/>
          <p:nvPr/>
        </p:nvCxnSpPr>
        <p:spPr>
          <a:xfrm>
            <a:off x="3743320" y="4286260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직선 화살표 연결선 175"/>
          <p:cNvCxnSpPr/>
          <p:nvPr/>
        </p:nvCxnSpPr>
        <p:spPr>
          <a:xfrm>
            <a:off x="3743320" y="5138544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직선 화살표 연결선 176"/>
          <p:cNvCxnSpPr/>
          <p:nvPr/>
        </p:nvCxnSpPr>
        <p:spPr>
          <a:xfrm>
            <a:off x="1312716" y="5127496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239440" y="979860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-FoxO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239440" y="1629271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oxO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239440" y="2451075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400" dirty="0" smtClean="0">
                <a:latin typeface="Arial"/>
                <a:cs typeface="Arial"/>
              </a:rPr>
              <a:t>α</a:t>
            </a:r>
            <a:r>
              <a:rPr lang="en-US" altLang="ko-KR" sz="1400" dirty="0" smtClean="0">
                <a:latin typeface="Arial"/>
                <a:cs typeface="Arial"/>
              </a:rPr>
              <a:t>-Tubuli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239440" y="3462040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-FoxO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239440" y="4111451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oxO3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239440" y="4958655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400" dirty="0" smtClean="0">
                <a:latin typeface="Arial"/>
                <a:cs typeface="Arial"/>
              </a:rPr>
              <a:t>α</a:t>
            </a:r>
            <a:r>
              <a:rPr lang="en-US" altLang="ko-KR" sz="1400" dirty="0" smtClean="0">
                <a:latin typeface="Arial"/>
                <a:cs typeface="Arial"/>
              </a:rPr>
              <a:t>-Tubuli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82777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8588681"/>
              </p:ext>
            </p:extLst>
          </p:nvPr>
        </p:nvGraphicFramePr>
        <p:xfrm>
          <a:off x="1192767" y="704528"/>
          <a:ext cx="4540489" cy="316835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3589"/>
                <a:gridCol w="673589"/>
                <a:gridCol w="673589"/>
                <a:gridCol w="698537"/>
                <a:gridCol w="1147596"/>
                <a:gridCol w="673589"/>
              </a:tblGrid>
              <a:tr h="186374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/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FoxO3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O3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FoxO3a/FoxO3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16.1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35.4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353216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31.6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33.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620116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09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 µM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32.31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65.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432232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115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99.1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9.01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84056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589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18.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87.10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656363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 µM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70.5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59.8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348104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96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32.7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42.0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3093747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79.65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94.2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412833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902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 µM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07.1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28.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08208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539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12.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93.66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43311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5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00.2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22.2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511615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970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 µM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81.0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553.9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22367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21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46.3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17.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534191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247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76.3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37.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666862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832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7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 µM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67.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14.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07610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85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4944357"/>
              </p:ext>
            </p:extLst>
          </p:nvPr>
        </p:nvGraphicFramePr>
        <p:xfrm>
          <a:off x="2053952" y="4225652"/>
          <a:ext cx="2743200" cy="2095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 µM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09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11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589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9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902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53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5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970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21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24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832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85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87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023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103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097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113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184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es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45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671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28672" y="272480"/>
            <a:ext cx="3388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Figure 2F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9735706"/>
              </p:ext>
            </p:extLst>
          </p:nvPr>
        </p:nvGraphicFramePr>
        <p:xfrm>
          <a:off x="476672" y="1079808"/>
          <a:ext cx="648072" cy="276835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4036"/>
                <a:gridCol w="324036"/>
              </a:tblGrid>
              <a:tr h="184557">
                <a:tc rowSpan="6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rowSpan="9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455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ko-KR" altLang="en-US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 rot="16200000">
            <a:off x="-6646" y="1525217"/>
            <a:ext cx="12961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f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-200019" y="2844200"/>
            <a:ext cx="1682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gh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90505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7454684"/>
              </p:ext>
            </p:extLst>
          </p:nvPr>
        </p:nvGraphicFramePr>
        <p:xfrm>
          <a:off x="1038448" y="848544"/>
          <a:ext cx="4622800" cy="37719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711200"/>
                <a:gridCol w="11684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/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FoxO3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O3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FoxO3a/FoxO3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46.5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34.2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01234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57.36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602.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464966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53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3.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10.2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60379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9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43.25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693.7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639578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14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28.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74.06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87145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08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27.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46.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218998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49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82.2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6.8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162112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0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64.1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19.5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460610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94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28.8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28.5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5838429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08.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23.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793767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076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nM 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30.8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04.1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858422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70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4.1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94.4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579398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3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43.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59.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012087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442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85.1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44.5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204684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59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32.8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43.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84032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980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97.3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47.8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31150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037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6176181"/>
              </p:ext>
            </p:extLst>
          </p:nvPr>
        </p:nvGraphicFramePr>
        <p:xfrm>
          <a:off x="1628800" y="4867250"/>
          <a:ext cx="3429000" cy="18859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x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53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9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14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089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493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0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94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076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701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3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44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59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980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03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1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174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670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91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718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037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489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653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es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288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443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32656" y="416496"/>
            <a:ext cx="3235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</a:t>
            </a:r>
            <a:r>
              <a:rPr lang="en-GB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</a:t>
            </a:r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G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7285301"/>
              </p:ext>
            </p:extLst>
          </p:nvPr>
        </p:nvGraphicFramePr>
        <p:xfrm>
          <a:off x="226820" y="1265352"/>
          <a:ext cx="720000" cy="33406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/>
                <a:gridCol w="360000"/>
              </a:tblGrid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 rot="16200000">
            <a:off x="-237669" y="1953073"/>
            <a:ext cx="12961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f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-438662" y="3610000"/>
            <a:ext cx="1682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gh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70039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778947"/>
            <a:ext cx="1155700" cy="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0507" y="778947"/>
            <a:ext cx="750887" cy="611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0897" y="778947"/>
            <a:ext cx="1165225" cy="779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0278" y="778947"/>
            <a:ext cx="779463" cy="723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1665194"/>
            <a:ext cx="1155700" cy="769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0507" y="1665194"/>
            <a:ext cx="760413" cy="723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472" y="1665194"/>
            <a:ext cx="1136650" cy="676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9804" y="1665194"/>
            <a:ext cx="769937" cy="676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1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3455596"/>
            <a:ext cx="1098550" cy="376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5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0507" y="3455596"/>
            <a:ext cx="769937" cy="357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16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472" y="3328045"/>
            <a:ext cx="1136650" cy="403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17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0754" y="3322097"/>
            <a:ext cx="788987" cy="385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1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2584852"/>
            <a:ext cx="1117600" cy="714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9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0507" y="2584852"/>
            <a:ext cx="788987" cy="666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20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947" y="2584852"/>
            <a:ext cx="1146175" cy="488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21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0754" y="2584852"/>
            <a:ext cx="788987" cy="422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2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3963518"/>
            <a:ext cx="1136650" cy="601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23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0507" y="4006380"/>
            <a:ext cx="836613" cy="515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24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9472" y="3935735"/>
            <a:ext cx="1136650" cy="657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25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1228" y="4006378"/>
            <a:ext cx="798513" cy="515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TextBox 23"/>
          <p:cNvSpPr txBox="1"/>
          <p:nvPr/>
        </p:nvSpPr>
        <p:spPr>
          <a:xfrm>
            <a:off x="332657" y="4810725"/>
            <a:ext cx="62646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blot images related to Figure 3D) : 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membrane images </a:t>
            </a:r>
            <a:r>
              <a:rPr lang="en-US" altLang="ko-KR" sz="12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f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or Figure 3D) red arrows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idicate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designated protein size. 1: Untreated control 2: 150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M</a:t>
            </a:r>
            <a:r>
              <a:rPr lang="en-US" altLang="ko-KR" sz="1200" dirty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of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iclosamide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3: 300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M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of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iclosamide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4: 600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M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 of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/>
                <a:cs typeface="Times New Roman" panose="02020603050405020304" pitchFamily="18" charset="0"/>
              </a:rPr>
              <a:t>niclosamide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17514" y="128464"/>
            <a:ext cx="47396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Figure 3D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624608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815065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005522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195979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472189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662646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853103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043560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3840341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030798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221255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411712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712821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903278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093735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284192" y="60712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1599772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790229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980686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2171143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490895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2681352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871809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062266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859047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4049504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239961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4430418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746041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4936498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5126955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5317412" y="154130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570744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761201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951658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2142115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461867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652324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842781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3033238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830019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4020476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4210933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4401390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4717013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907470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5097927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5288384" y="236129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578004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768461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958918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2149375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2469127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2659584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2850041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3040498" y="3297396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3837279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4027736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4218193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4408650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4724273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4914730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5105187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5295644" y="3210874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585258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775715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966172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156629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2476381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666838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857295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3047752" y="3788062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815505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4005962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4196419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4386876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4702499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4892956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5083413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5273870" y="3701540"/>
            <a:ext cx="144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</a:t>
            </a:r>
            <a:endParaRPr lang="ko-KR" altLang="en-US" sz="8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162" name="직선 화살표 연결선 161"/>
          <p:cNvCxnSpPr/>
          <p:nvPr/>
        </p:nvCxnSpPr>
        <p:spPr>
          <a:xfrm>
            <a:off x="1075596" y="912932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직선 화살표 연결선 162"/>
          <p:cNvCxnSpPr/>
          <p:nvPr/>
        </p:nvCxnSpPr>
        <p:spPr>
          <a:xfrm>
            <a:off x="1075596" y="1882944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직선 화살표 연결선 163"/>
          <p:cNvCxnSpPr/>
          <p:nvPr/>
        </p:nvCxnSpPr>
        <p:spPr>
          <a:xfrm>
            <a:off x="1075596" y="2720752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직선 화살표 연결선 164"/>
          <p:cNvCxnSpPr/>
          <p:nvPr/>
        </p:nvCxnSpPr>
        <p:spPr>
          <a:xfrm>
            <a:off x="1075596" y="3656856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직선 화살표 연결선 165"/>
          <p:cNvCxnSpPr/>
          <p:nvPr/>
        </p:nvCxnSpPr>
        <p:spPr>
          <a:xfrm>
            <a:off x="1075596" y="4093096"/>
            <a:ext cx="206740" cy="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66"/>
          <p:cNvSpPr txBox="1"/>
          <p:nvPr/>
        </p:nvSpPr>
        <p:spPr>
          <a:xfrm>
            <a:off x="82724" y="751136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82724" y="1705595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82724" y="2576736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trogin-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82724" y="3512840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uRF-1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82724" y="3910980"/>
            <a:ext cx="1065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400" dirty="0" smtClean="0">
                <a:latin typeface="Arial"/>
                <a:cs typeface="Arial"/>
              </a:rPr>
              <a:t>α</a:t>
            </a:r>
            <a:r>
              <a:rPr lang="en-US" altLang="ko-KR" sz="1400" dirty="0" smtClean="0">
                <a:latin typeface="Arial"/>
                <a:cs typeface="Arial"/>
              </a:rPr>
              <a:t>-Tubuli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74445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8017793"/>
              </p:ext>
            </p:extLst>
          </p:nvPr>
        </p:nvGraphicFramePr>
        <p:xfrm>
          <a:off x="1022350" y="920552"/>
          <a:ext cx="4813300" cy="37719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13843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/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22.7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31.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892071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74.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57.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738675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996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61.31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50.4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472546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89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63.28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70.0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327812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058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35.76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39.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387629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92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33.24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94.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613266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264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43.9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19.7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643643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7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13.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20.6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877962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993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06.3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10.78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853479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67.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85.2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05989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475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78.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31.3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467253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794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69.25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54.1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255347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336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5.9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950.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59148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946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20.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49.1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66228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319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56.2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76.5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10749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804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0.4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10.8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32215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894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3732380"/>
              </p:ext>
            </p:extLst>
          </p:nvPr>
        </p:nvGraphicFramePr>
        <p:xfrm>
          <a:off x="1714500" y="5011266"/>
          <a:ext cx="3429000" cy="18859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losamide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996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89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05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92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264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99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475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794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33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946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319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804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89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96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76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30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070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446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75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10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392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es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925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93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898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17514" y="128464"/>
            <a:ext cx="47396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Figure 3D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0835319"/>
              </p:ext>
            </p:extLst>
          </p:nvPr>
        </p:nvGraphicFramePr>
        <p:xfrm>
          <a:off x="226820" y="1349172"/>
          <a:ext cx="720000" cy="33406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/>
                <a:gridCol w="360000"/>
              </a:tblGrid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-237669" y="2036893"/>
            <a:ext cx="12961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f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-438662" y="3693820"/>
            <a:ext cx="1682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gh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75010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2902846"/>
              </p:ext>
            </p:extLst>
          </p:nvPr>
        </p:nvGraphicFramePr>
        <p:xfrm>
          <a:off x="1022350" y="920552"/>
          <a:ext cx="4813300" cy="37719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13843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/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ogin-1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ha-Tublin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ogin-1/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l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52.24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47.0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469876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59.18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07.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08679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65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69.44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68.9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132385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59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91.9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42.4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13921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684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98.1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34.5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384426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56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40.8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22.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712312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31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74.2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61.9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282135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29.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75.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017877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1158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47.4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83.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664098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78.2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91.6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951720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506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55.00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54.9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65957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353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12.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47.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537549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957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2.8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12.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353886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04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56.1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58.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395967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334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28.0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95.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152111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927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67.6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43.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375298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999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2127119"/>
              </p:ext>
            </p:extLst>
          </p:nvPr>
        </p:nvGraphicFramePr>
        <p:xfrm>
          <a:off x="1714500" y="4939258"/>
          <a:ext cx="3429000" cy="18859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losamide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65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59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684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56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311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1158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506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353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957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0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334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927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499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4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7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118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5643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52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98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120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923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es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19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47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75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17514" y="128464"/>
            <a:ext cx="47396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Figure 3D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6554882"/>
              </p:ext>
            </p:extLst>
          </p:nvPr>
        </p:nvGraphicFramePr>
        <p:xfrm>
          <a:off x="226820" y="1349172"/>
          <a:ext cx="720000" cy="33406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/>
                <a:gridCol w="360000"/>
              </a:tblGrid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-237669" y="2036893"/>
            <a:ext cx="12961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f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-438662" y="3693820"/>
            <a:ext cx="1682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gh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18206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6468644"/>
              </p:ext>
            </p:extLst>
          </p:nvPr>
        </p:nvGraphicFramePr>
        <p:xfrm>
          <a:off x="1022350" y="965076"/>
          <a:ext cx="4813300" cy="37719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13843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1/Target 2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rf-1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pha-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l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rf-1/alpha-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l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51.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47.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67264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41.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07.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36942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74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02.8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68.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91594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49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23.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42.4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963881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53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70.8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34.5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8750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527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26.2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22.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553017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6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63.3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61.9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575564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8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34.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75.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46053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03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23.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12.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670508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22.3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58.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532391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43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15.7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95.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92301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33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201.3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43.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846053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85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nM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38.5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583.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321976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87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56.4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91.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288769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20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13.1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54.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718113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150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69.86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47.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56672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455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5332639"/>
              </p:ext>
            </p:extLst>
          </p:nvPr>
        </p:nvGraphicFramePr>
        <p:xfrm>
          <a:off x="1714500" y="5227290"/>
          <a:ext cx="3429000" cy="18859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85800"/>
                <a:gridCol w="685800"/>
                <a:gridCol w="685800"/>
                <a:gridCol w="685800"/>
                <a:gridCol w="685800"/>
              </a:tblGrid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losamide 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</a:t>
                      </a:r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74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49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53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527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63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8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03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433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33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856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endParaRPr lang="ko-KR" alt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87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20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150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455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59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06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466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7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ev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37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7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970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41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es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6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849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17514" y="128464"/>
            <a:ext cx="47396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Figure 3D)</a:t>
            </a:r>
            <a:endParaRPr lang="en-GB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2342374"/>
              </p:ext>
            </p:extLst>
          </p:nvPr>
        </p:nvGraphicFramePr>
        <p:xfrm>
          <a:off x="226820" y="1387272"/>
          <a:ext cx="720000" cy="33406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60000"/>
                <a:gridCol w="360000"/>
              </a:tblGrid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rowSpan="8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8632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7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77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-237669" y="2074993"/>
            <a:ext cx="12961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f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-438662" y="3731920"/>
            <a:ext cx="1682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ght side membrane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3153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1207</Words>
  <Application>Microsoft Office PowerPoint</Application>
  <PresentationFormat>A4 용지(210x297mm)</PresentationFormat>
  <Paragraphs>920</Paragraphs>
  <Slides>7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8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윌리엄스</dc:creator>
  <cp:lastModifiedBy>윌리엄스</cp:lastModifiedBy>
  <cp:revision>20</cp:revision>
  <dcterms:created xsi:type="dcterms:W3CDTF">2020-09-25T13:13:44Z</dcterms:created>
  <dcterms:modified xsi:type="dcterms:W3CDTF">2021-04-16T04:50:29Z</dcterms:modified>
</cp:coreProperties>
</file>